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-1710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923373-A343-4C0F-9F35-9F188D060B12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ECD06-8051-4FED-AEA2-325E84A5DA6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012103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923373-A343-4C0F-9F35-9F188D060B12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ECD06-8051-4FED-AEA2-325E84A5DA6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775400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923373-A343-4C0F-9F35-9F188D060B12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ECD06-8051-4FED-AEA2-325E84A5DA6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873002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923373-A343-4C0F-9F35-9F188D060B12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ECD06-8051-4FED-AEA2-325E84A5DA6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361203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923373-A343-4C0F-9F35-9F188D060B12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ECD06-8051-4FED-AEA2-325E84A5DA6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201260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923373-A343-4C0F-9F35-9F188D060B12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ECD06-8051-4FED-AEA2-325E84A5DA6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45953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923373-A343-4C0F-9F35-9F188D060B12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ECD06-8051-4FED-AEA2-325E84A5DA6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470843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923373-A343-4C0F-9F35-9F188D060B12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ECD06-8051-4FED-AEA2-325E84A5DA6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572154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923373-A343-4C0F-9F35-9F188D060B12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ECD06-8051-4FED-AEA2-325E84A5DA6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803351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923373-A343-4C0F-9F35-9F188D060B12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ECD06-8051-4FED-AEA2-325E84A5DA6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313784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923373-A343-4C0F-9F35-9F188D060B12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ECD06-8051-4FED-AEA2-325E84A5DA6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428209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923373-A343-4C0F-9F35-9F188D060B12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DECD06-8051-4FED-AEA2-325E84A5DA6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43746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2" name="Gruppieren 51"/>
          <p:cNvGrpSpPr/>
          <p:nvPr/>
        </p:nvGrpSpPr>
        <p:grpSpPr>
          <a:xfrm>
            <a:off x="348067" y="1185366"/>
            <a:ext cx="3028393" cy="774749"/>
            <a:chOff x="1307243" y="2904386"/>
            <a:chExt cx="3028393" cy="774749"/>
          </a:xfrm>
        </p:grpSpPr>
        <p:pic>
          <p:nvPicPr>
            <p:cNvPr id="76" name="Grafik 75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085" t="47957" r="23478" b="48189"/>
            <a:stretch/>
          </p:blipFill>
          <p:spPr>
            <a:xfrm>
              <a:off x="1801323" y="3287286"/>
              <a:ext cx="2534313" cy="389870"/>
            </a:xfrm>
            <a:prstGeom prst="rect">
              <a:avLst/>
            </a:prstGeom>
          </p:spPr>
        </p:pic>
        <p:sp>
          <p:nvSpPr>
            <p:cNvPr id="77" name="Rechteck 76"/>
            <p:cNvSpPr/>
            <p:nvPr/>
          </p:nvSpPr>
          <p:spPr>
            <a:xfrm rot="16200000">
              <a:off x="3908629" y="3013312"/>
              <a:ext cx="41069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defTabSz="685800">
                <a:defRPr/>
              </a:pPr>
              <a:r>
                <a:rPr lang="de-DE" sz="1000" b="1" kern="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16</a:t>
              </a:r>
              <a:endParaRPr lang="de-DE" sz="10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Rechteck 77"/>
            <p:cNvSpPr/>
            <p:nvPr/>
          </p:nvSpPr>
          <p:spPr>
            <a:xfrm rot="16200000">
              <a:off x="2048797" y="3027136"/>
              <a:ext cx="375787" cy="28612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defTabSz="6858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9</a:t>
              </a:r>
              <a:endParaRPr kumimoji="0" lang="de-DE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Rechteck 78"/>
            <p:cNvSpPr/>
            <p:nvPr/>
          </p:nvSpPr>
          <p:spPr>
            <a:xfrm rot="16200000">
              <a:off x="2513893" y="2988177"/>
              <a:ext cx="453707" cy="28612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defTabSz="6858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11</a:t>
              </a:r>
              <a:endParaRPr kumimoji="0" lang="de-DE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Rechteck 79"/>
            <p:cNvSpPr/>
            <p:nvPr/>
          </p:nvSpPr>
          <p:spPr>
            <a:xfrm rot="16200000">
              <a:off x="2225861" y="2988177"/>
              <a:ext cx="453707" cy="28612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defTabSz="6858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10</a:t>
              </a:r>
              <a:endParaRPr kumimoji="0" lang="de-DE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Rechteck 80"/>
            <p:cNvSpPr/>
            <p:nvPr/>
          </p:nvSpPr>
          <p:spPr>
            <a:xfrm rot="16200000">
              <a:off x="2801925" y="2988177"/>
              <a:ext cx="453707" cy="28612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defTabSz="6858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12</a:t>
              </a:r>
              <a:endParaRPr kumimoji="0" lang="de-DE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Rechteck 81"/>
            <p:cNvSpPr/>
            <p:nvPr/>
          </p:nvSpPr>
          <p:spPr>
            <a:xfrm rot="16200000">
              <a:off x="3089957" y="2988177"/>
              <a:ext cx="453707" cy="28612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defTabSz="6858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13</a:t>
              </a:r>
              <a:endParaRPr kumimoji="0" lang="de-DE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Rechteck 82"/>
            <p:cNvSpPr/>
            <p:nvPr/>
          </p:nvSpPr>
          <p:spPr>
            <a:xfrm rot="16200000">
              <a:off x="3377989" y="2988177"/>
              <a:ext cx="453707" cy="28612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defTabSz="685800">
                <a:defRPr/>
              </a:pPr>
              <a:r>
                <a:rPr lang="de-DE" sz="1000" b="1" kern="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14</a:t>
              </a:r>
              <a:endParaRPr lang="de-DE" sz="10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Rechteck 83"/>
            <p:cNvSpPr/>
            <p:nvPr/>
          </p:nvSpPr>
          <p:spPr>
            <a:xfrm>
              <a:off x="1801323" y="3080734"/>
              <a:ext cx="296558" cy="27201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defTabSz="685800">
                <a:defRPr/>
              </a:pPr>
              <a:r>
                <a:rPr lang="de-DE" sz="1000" b="1" kern="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de-DE" sz="10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Rechteck 84"/>
            <p:cNvSpPr/>
            <p:nvPr/>
          </p:nvSpPr>
          <p:spPr>
            <a:xfrm rot="16200000">
              <a:off x="3666795" y="2988177"/>
              <a:ext cx="453707" cy="28612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defTabSz="6858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15</a:t>
              </a:r>
              <a:endParaRPr kumimoji="0" lang="de-DE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Rechteck 85"/>
            <p:cNvSpPr/>
            <p:nvPr/>
          </p:nvSpPr>
          <p:spPr>
            <a:xfrm>
              <a:off x="1307243" y="3355970"/>
              <a:ext cx="731891" cy="3231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 defTabSz="685800">
                <a:lnSpc>
                  <a:spcPts val="900"/>
                </a:lnSpc>
                <a:defRPr/>
              </a:pPr>
              <a:r>
                <a:rPr lang="de-DE" sz="10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2kDa-</a:t>
              </a:r>
            </a:p>
            <a:p>
              <a:pPr lvl="0" defTabSz="685800">
                <a:lnSpc>
                  <a:spcPts val="900"/>
                </a:lnSpc>
                <a:defRPr/>
              </a:pPr>
              <a:endParaRPr lang="de-DE" sz="10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3" name="Gruppieren 52"/>
          <p:cNvGrpSpPr/>
          <p:nvPr/>
        </p:nvGrpSpPr>
        <p:grpSpPr>
          <a:xfrm>
            <a:off x="388632" y="1879808"/>
            <a:ext cx="3009728" cy="760917"/>
            <a:chOff x="1408974" y="5352658"/>
            <a:chExt cx="3009728" cy="760917"/>
          </a:xfrm>
        </p:grpSpPr>
        <p:pic>
          <p:nvPicPr>
            <p:cNvPr id="65" name="Grafik 64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939" t="66367" r="21607" b="29772"/>
            <a:stretch/>
          </p:blipFill>
          <p:spPr>
            <a:xfrm>
              <a:off x="1885970" y="5734133"/>
              <a:ext cx="2532732" cy="379442"/>
            </a:xfrm>
            <a:prstGeom prst="rect">
              <a:avLst/>
            </a:prstGeom>
          </p:spPr>
        </p:pic>
        <p:sp>
          <p:nvSpPr>
            <p:cNvPr id="66" name="Rechteck 65"/>
            <p:cNvSpPr/>
            <p:nvPr/>
          </p:nvSpPr>
          <p:spPr>
            <a:xfrm rot="16200000">
              <a:off x="2341235" y="5436449"/>
              <a:ext cx="453707" cy="28612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defTabSz="6858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18</a:t>
              </a:r>
              <a:endParaRPr kumimoji="0" lang="de-DE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Rechteck 66"/>
            <p:cNvSpPr/>
            <p:nvPr/>
          </p:nvSpPr>
          <p:spPr>
            <a:xfrm rot="16200000">
              <a:off x="2063672" y="5436449"/>
              <a:ext cx="453707" cy="28612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defTabSz="6858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17</a:t>
              </a:r>
              <a:endParaRPr kumimoji="0" lang="de-DE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Rechteck 67"/>
            <p:cNvSpPr/>
            <p:nvPr/>
          </p:nvSpPr>
          <p:spPr>
            <a:xfrm rot="16200000">
              <a:off x="2598671" y="5436449"/>
              <a:ext cx="453707" cy="28612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defTabSz="6858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19</a:t>
              </a:r>
              <a:endParaRPr kumimoji="0" lang="de-DE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Rechteck 68"/>
            <p:cNvSpPr/>
            <p:nvPr/>
          </p:nvSpPr>
          <p:spPr>
            <a:xfrm rot="16200000">
              <a:off x="2880465" y="5436449"/>
              <a:ext cx="453707" cy="28612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defTabSz="6858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20</a:t>
              </a:r>
              <a:endParaRPr kumimoji="0" lang="de-DE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Rechteck 69"/>
            <p:cNvSpPr/>
            <p:nvPr/>
          </p:nvSpPr>
          <p:spPr>
            <a:xfrm rot="16200000">
              <a:off x="3159793" y="5436449"/>
              <a:ext cx="453707" cy="28612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defTabSz="685800">
                <a:defRPr/>
              </a:pPr>
              <a:r>
                <a:rPr lang="de-DE" sz="1000" b="1" kern="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21</a:t>
              </a:r>
              <a:endParaRPr lang="de-DE" sz="10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Rechteck 70"/>
            <p:cNvSpPr/>
            <p:nvPr/>
          </p:nvSpPr>
          <p:spPr>
            <a:xfrm>
              <a:off x="1866016" y="5527229"/>
              <a:ext cx="296558" cy="27201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defTabSz="685800">
                <a:defRPr/>
              </a:pPr>
              <a:r>
                <a:rPr lang="de-DE" sz="1000" b="1" kern="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de-DE" sz="10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Rechteck 71"/>
            <p:cNvSpPr/>
            <p:nvPr/>
          </p:nvSpPr>
          <p:spPr>
            <a:xfrm rot="16200000">
              <a:off x="3391826" y="5441315"/>
              <a:ext cx="453707" cy="28612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defTabSz="6858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22</a:t>
              </a:r>
              <a:endParaRPr kumimoji="0" lang="de-DE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Rechteck 72"/>
            <p:cNvSpPr/>
            <p:nvPr/>
          </p:nvSpPr>
          <p:spPr>
            <a:xfrm rot="16200000">
              <a:off x="3659459" y="5441315"/>
              <a:ext cx="453707" cy="28612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defTabSz="6858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23</a:t>
              </a:r>
              <a:endParaRPr kumimoji="0" lang="de-DE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Rechteck 73"/>
            <p:cNvSpPr/>
            <p:nvPr/>
          </p:nvSpPr>
          <p:spPr>
            <a:xfrm rot="16200000">
              <a:off x="3965719" y="5441315"/>
              <a:ext cx="453707" cy="28612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defTabSz="6858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24</a:t>
              </a:r>
              <a:endParaRPr kumimoji="0" lang="de-DE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Rechteck 74"/>
            <p:cNvSpPr/>
            <p:nvPr/>
          </p:nvSpPr>
          <p:spPr>
            <a:xfrm>
              <a:off x="1408974" y="5711273"/>
              <a:ext cx="596638" cy="20774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defTabSz="685800">
                <a:lnSpc>
                  <a:spcPts val="900"/>
                </a:lnSpc>
                <a:defRPr/>
              </a:pPr>
              <a:r>
                <a:rPr lang="de-DE" sz="10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2kDa-</a:t>
              </a:r>
            </a:p>
          </p:txBody>
        </p:sp>
      </p:grpSp>
      <p:pic>
        <p:nvPicPr>
          <p:cNvPr id="54" name="Grafik 5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851" t="30449" r="27997" b="65847"/>
          <a:stretch/>
        </p:blipFill>
        <p:spPr>
          <a:xfrm>
            <a:off x="856024" y="859361"/>
            <a:ext cx="2520436" cy="423871"/>
          </a:xfrm>
          <a:prstGeom prst="rect">
            <a:avLst/>
          </a:prstGeom>
        </p:spPr>
      </p:pic>
      <p:sp>
        <p:nvSpPr>
          <p:cNvPr id="55" name="Rechteck 54"/>
          <p:cNvSpPr/>
          <p:nvPr/>
        </p:nvSpPr>
        <p:spPr>
          <a:xfrm rot="16200000">
            <a:off x="1060518" y="582125"/>
            <a:ext cx="375787" cy="28612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defTabSz="6858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000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1</a:t>
            </a:r>
            <a:endParaRPr kumimoji="0" lang="de-DE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Rechteck 55"/>
          <p:cNvSpPr/>
          <p:nvPr/>
        </p:nvSpPr>
        <p:spPr>
          <a:xfrm rot="16200000">
            <a:off x="1337120" y="582125"/>
            <a:ext cx="375787" cy="28612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defTabSz="6858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000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2</a:t>
            </a:r>
            <a:endParaRPr kumimoji="0" lang="de-DE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Rechteck 56"/>
          <p:cNvSpPr/>
          <p:nvPr/>
        </p:nvSpPr>
        <p:spPr>
          <a:xfrm rot="16200000">
            <a:off x="1867464" y="582125"/>
            <a:ext cx="375787" cy="28612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defTabSz="6858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000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4</a:t>
            </a:r>
            <a:endParaRPr kumimoji="0" lang="de-DE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Rechteck 57"/>
          <p:cNvSpPr/>
          <p:nvPr/>
        </p:nvSpPr>
        <p:spPr>
          <a:xfrm rot="16200000">
            <a:off x="1584729" y="582125"/>
            <a:ext cx="375787" cy="28612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defTabSz="6858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000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3</a:t>
            </a:r>
            <a:endParaRPr kumimoji="0" lang="de-DE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Rechteck 58"/>
          <p:cNvSpPr/>
          <p:nvPr/>
        </p:nvSpPr>
        <p:spPr>
          <a:xfrm rot="16200000">
            <a:off x="2124634" y="582125"/>
            <a:ext cx="375787" cy="28612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defTabSz="6858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000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5</a:t>
            </a:r>
            <a:endParaRPr kumimoji="0" lang="de-DE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Rechteck 59"/>
          <p:cNvSpPr/>
          <p:nvPr/>
        </p:nvSpPr>
        <p:spPr>
          <a:xfrm rot="16200000">
            <a:off x="2397808" y="582125"/>
            <a:ext cx="375787" cy="28612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defTabSz="6858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000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6</a:t>
            </a:r>
            <a:endParaRPr kumimoji="0" lang="de-DE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Rechteck 60"/>
          <p:cNvSpPr/>
          <p:nvPr/>
        </p:nvSpPr>
        <p:spPr>
          <a:xfrm rot="16200000">
            <a:off x="2685840" y="582125"/>
            <a:ext cx="375787" cy="28612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defTabSz="685800">
              <a:defRPr/>
            </a:pPr>
            <a:r>
              <a:rPr lang="de-DE" sz="1000" b="1" kern="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7</a:t>
            </a:r>
            <a:endParaRPr lang="de-DE" sz="1000" b="1" kern="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Rechteck 61"/>
          <p:cNvSpPr/>
          <p:nvPr/>
        </p:nvSpPr>
        <p:spPr>
          <a:xfrm>
            <a:off x="787600" y="615181"/>
            <a:ext cx="296558" cy="27201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defTabSz="685800">
              <a:defRPr/>
            </a:pPr>
            <a:r>
              <a:rPr lang="de-DE" sz="1000" b="1" kern="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de-DE" sz="1000" b="1" kern="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Rechteck 62"/>
          <p:cNvSpPr/>
          <p:nvPr/>
        </p:nvSpPr>
        <p:spPr>
          <a:xfrm rot="16200000">
            <a:off x="2993590" y="611891"/>
            <a:ext cx="34015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defTabSz="685800">
              <a:defRPr/>
            </a:pPr>
            <a:r>
              <a:rPr lang="de-DE" sz="1000" b="1" kern="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8</a:t>
            </a:r>
            <a:endParaRPr lang="de-DE" sz="1000" b="1" kern="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Rechteck 63"/>
          <p:cNvSpPr/>
          <p:nvPr/>
        </p:nvSpPr>
        <p:spPr>
          <a:xfrm>
            <a:off x="354410" y="866357"/>
            <a:ext cx="596638" cy="20774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defTabSz="685800">
              <a:lnSpc>
                <a:spcPts val="900"/>
              </a:lnSpc>
              <a:defRPr/>
            </a:pPr>
            <a:r>
              <a:rPr lang="de-DE" sz="10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2kDa-</a:t>
            </a:r>
          </a:p>
        </p:txBody>
      </p:sp>
      <p:sp>
        <p:nvSpPr>
          <p:cNvPr id="51" name="Rechteck 50"/>
          <p:cNvSpPr/>
          <p:nvPr/>
        </p:nvSpPr>
        <p:spPr>
          <a:xfrm>
            <a:off x="416494" y="2636912"/>
            <a:ext cx="3954929" cy="3231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>
              <a:lnSpc>
                <a:spcPct val="150000"/>
              </a:lnSpc>
            </a:pPr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2 Fig. </a:t>
            </a:r>
            <a:r>
              <a:rPr lang="de-DE" sz="10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esternblots</a:t>
            </a:r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ll </a:t>
            </a:r>
            <a:r>
              <a:rPr lang="de-DE" sz="10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tracts</a:t>
            </a:r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sted</a:t>
            </a:r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0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is</a:t>
            </a:r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udy</a:t>
            </a:r>
            <a:endParaRPr lang="de-DE" sz="1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27376878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2</Words>
  <Application>Microsoft Office PowerPoint</Application>
  <PresentationFormat>Bildschirmpräsentation (4:3)</PresentationFormat>
  <Paragraphs>31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niklinikum Freibur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r. Anke Tscheuschler</dc:creator>
  <cp:lastModifiedBy>Dr. Anke Tscheuschler</cp:lastModifiedBy>
  <cp:revision>1</cp:revision>
  <dcterms:created xsi:type="dcterms:W3CDTF">2016-09-29T14:05:04Z</dcterms:created>
  <dcterms:modified xsi:type="dcterms:W3CDTF">2016-09-29T14:06:14Z</dcterms:modified>
</cp:coreProperties>
</file>